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2124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784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4304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8138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9626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60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633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0204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1301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8713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4690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1190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EC82F-387B-42EC-BFA1-648EF321BB73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7765C-12CD-46FD-9807-BB160E24A1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989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16AC945-EE4D-4D2E-BD67-22070378CE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3677011"/>
              </p:ext>
            </p:extLst>
          </p:nvPr>
        </p:nvGraphicFramePr>
        <p:xfrm>
          <a:off x="1612900" y="1737519"/>
          <a:ext cx="3263900" cy="6076950"/>
        </p:xfrm>
        <a:graphic>
          <a:graphicData uri="http://schemas.openxmlformats.org/drawingml/2006/table">
            <a:tbl>
              <a:tblPr/>
              <a:tblGrid>
                <a:gridCol w="876300">
                  <a:extLst>
                    <a:ext uri="{9D8B030D-6E8A-4147-A177-3AD203B41FA5}">
                      <a16:colId xmlns:a16="http://schemas.microsoft.com/office/drawing/2014/main" val="831588484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1804995086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34356561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1197486444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igin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b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47301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loven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66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0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16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152487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witzerland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130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2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32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831400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witzerland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15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1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33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427011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rance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00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3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35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509428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ustr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0.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36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750266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ermany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62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7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37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325108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ales Br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64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5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39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847198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ales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4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090736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weden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1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51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41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170808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etherlands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57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6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43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821185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inland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97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55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44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672264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enmark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102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9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45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115330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uss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94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57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50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7908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uss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96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58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51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718183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uss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333c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59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52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536870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zech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8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48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58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326885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oland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6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1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59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548693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lovak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0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2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60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823458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oman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394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4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62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006629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oman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395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5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63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675988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ustr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ue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2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64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17206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ustr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195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1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65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099611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witzerland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110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7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68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172149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taly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42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6.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69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268905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taly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44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9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0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631539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taly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6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68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1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802419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b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4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6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3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905474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b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4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7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4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085519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sn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6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3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6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349160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sn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6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4.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7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100497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sn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2563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75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8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200929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ulgari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b410C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5980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Q186079.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235335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B7B1016-8FEE-4E85-8B67-948FA2DE27EE}"/>
              </a:ext>
            </a:extLst>
          </p:cNvPr>
          <p:cNvSpPr txBox="1"/>
          <p:nvPr/>
        </p:nvSpPr>
        <p:spPr>
          <a:xfrm>
            <a:off x="838200" y="8306117"/>
            <a:ext cx="51816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Table</a:t>
            </a:r>
            <a:r>
              <a:rPr lang="en-GB" sz="1600" dirty="0"/>
              <a:t>  Country of origin, sample identifier and </a:t>
            </a:r>
            <a:r>
              <a:rPr lang="en-GB" sz="1600" dirty="0" err="1"/>
              <a:t>Genbank</a:t>
            </a:r>
            <a:r>
              <a:rPr lang="en-GB" sz="1600" dirty="0"/>
              <a:t> sequences used to prepare </a:t>
            </a:r>
            <a:r>
              <a:rPr lang="en-GB" sz="1600" dirty="0" err="1"/>
              <a:t>Ctyb</a:t>
            </a:r>
            <a:r>
              <a:rPr lang="en-GB" sz="1600" dirty="0"/>
              <a:t>/CR concatenated sequence alignment for phylogenetic analysis of UKAGP relative to European mainland.  </a:t>
            </a: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489D0444-63FA-4FB4-A540-03B9469D33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9800" y="9838928"/>
            <a:ext cx="4851400" cy="123110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All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Genbank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 samples referenc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Ursenbacher,S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.,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Carlsson,M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.,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Helfer,V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.,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Tegelstrom,H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.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Fumagalli,L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.  Phylogeography and Pleistocene refugia of the adder (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Vipera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berus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) as inferred from mitochondrial DNA sequence data  Mol. Ecol. 15 (11), 3425-3437 (2006)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9C4372-319A-491B-B901-782153929211}"/>
              </a:ext>
            </a:extLst>
          </p:cNvPr>
          <p:cNvSpPr txBox="1"/>
          <p:nvPr/>
        </p:nvSpPr>
        <p:spPr>
          <a:xfrm>
            <a:off x="797442" y="1156959"/>
            <a:ext cx="4759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 S1 Table </a:t>
            </a:r>
            <a:r>
              <a:rPr lang="en-GB" sz="1400" dirty="0" err="1"/>
              <a:t>Genbank</a:t>
            </a:r>
            <a:r>
              <a:rPr lang="en-GB" sz="1400" dirty="0"/>
              <a:t> sequences used in phylogenetic analysis</a:t>
            </a:r>
          </a:p>
        </p:txBody>
      </p:sp>
    </p:spTree>
    <p:extLst>
      <p:ext uri="{BB962C8B-B14F-4D97-AF65-F5344CB8AC3E}">
        <p14:creationId xmlns:p14="http://schemas.microsoft.com/office/powerpoint/2010/main" val="2991193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3</TotalTime>
  <Words>225</Words>
  <Application>Microsoft Office PowerPoint</Application>
  <PresentationFormat>Widescreen</PresentationFormat>
  <Paragraphs>1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Ball</dc:creator>
  <cp:lastModifiedBy>Sarah Ball</cp:lastModifiedBy>
  <cp:revision>15</cp:revision>
  <dcterms:created xsi:type="dcterms:W3CDTF">2020-03-17T15:32:08Z</dcterms:created>
  <dcterms:modified xsi:type="dcterms:W3CDTF">2020-03-22T17:08:11Z</dcterms:modified>
</cp:coreProperties>
</file>